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10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95536" y="4948806"/>
            <a:ext cx="828092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itchFamily="18" charset="0"/>
                <a:cs typeface="Times New Roman" pitchFamily="18" charset="0"/>
              </a:rPr>
              <a:t>Figure. S3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The expression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pattern analysis of 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OsPUB73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in Taichung 65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. A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B showed the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spatial and temporal </a:t>
            </a:r>
            <a:r>
              <a:rPr lang="en-US" altLang="zh-CN" dirty="0" smtClean="0">
                <a:latin typeface="Times New Roman" pitchFamily="18" charset="0"/>
                <a:cs typeface="Times New Roman" pitchFamily="18" charset="0"/>
              </a:rPr>
              <a:t>expression patterns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CN" i="1" dirty="0">
                <a:latin typeface="Times New Roman" pitchFamily="18" charset="0"/>
                <a:cs typeface="Times New Roman" pitchFamily="18" charset="0"/>
              </a:rPr>
              <a:t>OsPUB73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in Taichung 65 by RT-PCR and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-PCR, PMA, MA, SCP, BCP and CS represent </a:t>
            </a:r>
            <a:r>
              <a:rPr lang="en-US" altLang="zh-CN" smtClean="0">
                <a:latin typeface="Times New Roman" pitchFamily="18" charset="0"/>
                <a:cs typeface="Times New Roman" pitchFamily="18" charset="0"/>
              </a:rPr>
              <a:t>anther at pre-meiotic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, meiosis, single microspore stage, bi-cellular pollen stage and mature pollen stage, respectively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 descr="F:\华农\论文\投稿论文\第四篇\bmc plant biology\附录\新\未标题-4-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63688" y="116632"/>
            <a:ext cx="5472608" cy="46815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453699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6</TotalTime>
  <Words>63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PC</cp:lastModifiedBy>
  <cp:revision>10</cp:revision>
  <dcterms:created xsi:type="dcterms:W3CDTF">2019-06-13T02:47:12Z</dcterms:created>
  <dcterms:modified xsi:type="dcterms:W3CDTF">2019-10-24T12:45:46Z</dcterms:modified>
</cp:coreProperties>
</file>